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  <p:sldId id="270" r:id="rId6"/>
    <p:sldId id="261" r:id="rId7"/>
    <p:sldId id="262" r:id="rId8"/>
    <p:sldId id="263" r:id="rId9"/>
    <p:sldId id="264" r:id="rId10"/>
    <p:sldId id="272" r:id="rId11"/>
    <p:sldId id="266" r:id="rId12"/>
    <p:sldId id="267" r:id="rId13"/>
    <p:sldId id="268" r:id="rId14"/>
    <p:sldId id="265" r:id="rId15"/>
    <p:sldId id="271" r:id="rId16"/>
    <p:sldId id="269" r:id="rId17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924FC-C3DE-4C5F-9014-C72C1E1071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788998-7519-4159-B3F6-735AA8D666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234E8-6DF5-4149-A2E2-3B567FF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DF923-999B-4A3A-9AD1-AFA47BD60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242756-336D-4F75-9A0B-E488E65FA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10643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21CE7-F76E-4902-9312-912ED3EEA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003337-4499-4A59-86F9-AEE4669FDB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91B89-B5FD-46AB-ABE0-30BC5E9D6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C52DD-4CF8-485C-979F-9C2A692EF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61CB21-9DDC-491C-A626-94F1FBB14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29852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08709E-1E21-4961-978D-1755EC435A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36A78E-F7F1-4695-925E-3D5DA2DD50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CA704-AD20-4CC4-A432-C1EEC03F8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18F36C-3D58-4343-9E26-9C7D69A30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41F66-0531-4D59-87C5-C89A54337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0357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0D93D-C884-4560-9A57-F57A4288D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6136FF-BB5B-40DF-8AB0-20DD3B751A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ECBC9C-1407-4FD3-8D10-CF55484F1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8DDE8-9C10-4B8C-A231-D59266040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646612-38A2-453F-AFED-483B7D8C5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7945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9D3ABD-AA87-4A2B-B5C5-CB43C4F9F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18F7AB-86D0-49F7-89CA-F6CE57FE4C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17FC15-E635-4B89-9231-F33ACA91B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6A54DD-5901-4C36-A2C3-8E2585440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09E32E-D85C-44DF-8164-174E4EAD6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83831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738828-D346-4F1E-A289-DF498B772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A15488-D53A-43A7-B3F4-222F0FF4C7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40D865-1D3B-4DF5-BB05-EE7B4FC76A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CBF9DA-0B6D-49F0-9800-C1B2177A2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269852-0894-4B1A-A29C-0907825EC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D7744D-8994-4A98-9744-D575EE762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05709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66938-EFF9-4ACC-8359-81BE31C71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411846-0F02-42B7-AA37-2D2C01EF2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66D9D7-66D0-488F-A619-334B454A0D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57A221-0200-4ABB-B89C-1ED4037A62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977DB-1886-4DAA-BAE0-DE72E829C4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C35F5D-D42C-48FA-9ED7-64CFB68A6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112A28-51FD-4FEC-B721-A2D18BE3E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8A5E9A-5A61-4202-9509-B56BF74C0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37590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1A820A-1293-4712-BABF-EF008D2E5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F85AC3-A773-4C23-B763-7145896A4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6776D5-4908-489F-9D75-5F70D9E3E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B3726B-ADE3-42D9-950B-18067C6B0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96151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D0C3A86-D981-4C7A-B40B-CEBB01F10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CFFEC1-5A88-4E5B-B883-A12B80B00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F22702-FA52-46D4-A795-1D0F1063E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26236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257E8-C457-4872-A27C-D72A7727C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D15F75-A5B3-4674-951F-566FE30BA6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B84634-22F7-47B1-8506-1FA6B8C812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EB092D-16EA-4921-B931-6015C6DD7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6C725-5AF7-4A27-A4B4-B6E1931DF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DA58EE-E045-4C85-98F6-10F7182DF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33891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4DEA35-5C00-495B-9126-FBB4FC1D48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8D42DB-A038-4DAA-BCBD-0C69F0781A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800B20-42C0-42B7-8870-D5B893E0B8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A2266E-82F4-43AA-9839-B8FDC7A8B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DE8E33-725A-4110-84BD-781FA0018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BB9FEA-0D27-4212-95E4-FD6DDCA2B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54858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994EAC-6360-4E5A-8E32-C95B3EF819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B1A154-435F-4681-863B-14ABA12042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584C0F-E8BE-452A-8C32-56D5C8DBC0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4632B-3F14-4D90-94E2-22688D96E761}" type="datetimeFigureOut">
              <a:rPr lang="en-DE" smtClean="0"/>
              <a:t>04/11/2020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6BB5F-DE57-49AD-92DC-DEC2425081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F7FEF5-BEA6-4CC4-A696-6281BC1C65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C3D2BE-F6FF-4BA1-8838-2A2BC581E74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6150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0526C14-D8D2-4296-8864-B3AEAF79EF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2355" y="739868"/>
            <a:ext cx="7167290" cy="53782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658D167-98F5-4CD5-9888-E865F565DF82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ypical shopping basket bought at the supermarket (HH6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68BD3B-3560-4B92-9078-4FF6053EA1FD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11937307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Food discussion during first visit (HH4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6A6E2E5-2A46-4752-870C-01F227EA5AC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14"/>
          <a:stretch/>
        </p:blipFill>
        <p:spPr>
          <a:xfrm>
            <a:off x="3244079" y="1935690"/>
            <a:ext cx="5703842" cy="2986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60244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label discussion during third visit (HH2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113DB31-E26E-4097-B3DE-6C3FC00032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5459" y="2037471"/>
            <a:ext cx="8309223" cy="27830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610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rocery stocks, fridge (HH3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2BBA477-EC36-4953-9A62-3D6164A206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40" y="1712940"/>
            <a:ext cx="5642060" cy="315864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72667DC-33A9-4762-8CF2-F66FF8E297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9009" y="1712939"/>
            <a:ext cx="5636829" cy="3158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3031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rocery stocks, larders (HH4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3825B23-6989-4308-86B8-82CD21D271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761" y="1820313"/>
            <a:ext cx="5537724" cy="321737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86C43CD-7A9A-4DC7-ABB0-0EFE7F8247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1517" y="1820313"/>
            <a:ext cx="5537723" cy="3174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63408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dinner preparation during first visit (HH1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E7A8AE7-AA53-4DD2-85F1-54895CA844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364" y="1201166"/>
            <a:ext cx="8126977" cy="4455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80905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lunch preparation during second visit (HH2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0C9D79C-AB6B-431E-9D10-305CE6911F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2938" y="1441832"/>
            <a:ext cx="7145830" cy="3974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9385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Home grown tomatoes (HH4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3F4558A-EC3B-4172-957C-B28BA78C07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9434" y="1175389"/>
            <a:ext cx="8012837" cy="45072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913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ypical shopping basket bought at the farmers market (HH6)</a:t>
            </a:r>
            <a:endParaRPr lang="en-DE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F44B0F8-4ABF-462F-8A50-901ACA6576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4761" y="1064342"/>
            <a:ext cx="6302477" cy="47293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F321CB4-A1D0-48A4-BF26-B99EA1CC78F5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2571659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ypical shopping basket bought at the supermarket (HH3)</a:t>
            </a:r>
            <a:endParaRPr lang="en-DE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9458C85-42D3-411F-BF4C-3380CD55C6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2493" y="797868"/>
            <a:ext cx="7207014" cy="526226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6716C7C-186C-4C68-9A37-18D66C6E8B7B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4206379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nday breakfast (HH4)</a:t>
            </a:r>
            <a:endParaRPr lang="en-DE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F97E152-F8CF-4241-9E6D-AA44A0E50C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8543" y="903149"/>
            <a:ext cx="6734914" cy="50517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70FDB75-2CC1-40DE-8E05-EBC5DC477F02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37290346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Lunch (HH6)</a:t>
            </a:r>
            <a:endParaRPr lang="en-DE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70FDB75-2CC1-40DE-8E05-EBC5DC477F02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65D0826-5EF7-4A51-836F-6A72AD3CA87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6"/>
          <a:stretch/>
        </p:blipFill>
        <p:spPr>
          <a:xfrm rot="5400000">
            <a:off x="3492483" y="1113633"/>
            <a:ext cx="5207034" cy="4630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19522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eekday breakfast (HH5)</a:t>
            </a:r>
            <a:endParaRPr lang="en-DE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818A1F3-0BCE-443D-B84B-8EAB7860DF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3556" y="732408"/>
            <a:ext cx="4044888" cy="53931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2F27459-3B7A-4C32-8976-35BCBB0B227E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send by the household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5052190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shopping at the first visit (HH5)</a:t>
            </a:r>
            <a:endParaRPr lang="en-DE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70BFD03-097E-49CE-AEF4-4F64B2ED7B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4877" y="1026734"/>
            <a:ext cx="7382245" cy="48045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6BA88A0-E1D1-4C65-BE95-39760E084F12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30909582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shopping at the first visit (HH2)</a:t>
            </a:r>
            <a:endParaRPr lang="en-DE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C0699E3-88A5-4DB3-BD4E-C41FB8CC3F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318" y="1087075"/>
            <a:ext cx="8383363" cy="4683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17075001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CD49D7-A627-45FD-BE0A-E3FA645B259D}"/>
              </a:ext>
            </a:extLst>
          </p:cNvPr>
          <p:cNvSpPr txBox="1"/>
          <p:nvPr/>
        </p:nvSpPr>
        <p:spPr>
          <a:xfrm>
            <a:off x="2274163" y="155961"/>
            <a:ext cx="764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utual label discussion during third visit (HH1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DF9B6A-BB49-402B-AC76-DE9E69DCFC1A}"/>
              </a:ext>
            </a:extLst>
          </p:cNvPr>
          <p:cNvSpPr txBox="1"/>
          <p:nvPr/>
        </p:nvSpPr>
        <p:spPr>
          <a:xfrm>
            <a:off x="2684016" y="6332706"/>
            <a:ext cx="7643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hoto taken by the researchers</a:t>
            </a:r>
            <a:endParaRPr lang="en-DE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50AAE1-41B0-4B04-9DFA-528D7CEB95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3722" y="943762"/>
            <a:ext cx="8864261" cy="4970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6185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8</Words>
  <Application>Microsoft Office PowerPoint</Application>
  <PresentationFormat>Widescreen</PresentationFormat>
  <Paragraphs>32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 Meyer</dc:creator>
  <cp:lastModifiedBy>Kathrin Meyer</cp:lastModifiedBy>
  <cp:revision>7</cp:revision>
  <dcterms:created xsi:type="dcterms:W3CDTF">2020-11-03T13:26:35Z</dcterms:created>
  <dcterms:modified xsi:type="dcterms:W3CDTF">2020-11-04T09:15:03Z</dcterms:modified>
</cp:coreProperties>
</file>